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569" autoAdjust="0"/>
    <p:restoredTop sz="94660"/>
  </p:normalViewPr>
  <p:slideViewPr>
    <p:cSldViewPr snapToGrid="0">
      <p:cViewPr>
        <p:scale>
          <a:sx n="100" d="100"/>
          <a:sy n="100" d="100"/>
        </p:scale>
        <p:origin x="1170" y="-6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1232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488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13816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20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939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4267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9848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0438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471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3370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1480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28EB3-65CC-48A8-B5A4-9CECC206343A}" type="datetimeFigureOut">
              <a:rPr lang="zh-CN" altLang="en-US" smtClean="0"/>
              <a:t>2022/4/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6041C-53C3-4DD1-BEB0-73364CD4BF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5873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图片 1" descr="Supplementary Figure 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207"/>
          <a:stretch/>
        </p:blipFill>
        <p:spPr bwMode="auto">
          <a:xfrm>
            <a:off x="794024" y="832347"/>
            <a:ext cx="5153025" cy="19847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5" name="Picture 1" descr="Supplementary Fig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0923" y="5129568"/>
            <a:ext cx="3371850" cy="1752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Rectangle 3"/>
          <p:cNvSpPr>
            <a:spLocks noChangeArrowheads="1"/>
          </p:cNvSpPr>
          <p:nvPr/>
        </p:nvSpPr>
        <p:spPr bwMode="auto">
          <a:xfrm>
            <a:off x="4302708" y="47384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142640" tIns="914112" rIns="1142640" bIns="914112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0" name="Rectangle 4"/>
          <p:cNvSpPr>
            <a:spLocks noChangeArrowheads="1"/>
          </p:cNvSpPr>
          <p:nvPr/>
        </p:nvSpPr>
        <p:spPr bwMode="auto">
          <a:xfrm>
            <a:off x="794024" y="2817076"/>
            <a:ext cx="5410509" cy="17543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ression profiles of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LBD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in the susceptible soybean cultivar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Huanchun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6 upon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.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oja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nfection. 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宋体" panose="02010600030101010101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oybean hairy roots were collected at 0, 1.5, 3, 6, 12, 16, 20 and 24 hours post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.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ojae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train P6497 infection. Total RNA was extracted and expression profiles of seven </a:t>
            </a:r>
            <a:r>
              <a:rPr kumimoji="0" lang="en-US" altLang="zh-CN" sz="12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LBD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at various time points during infection were determined by QRT-PCR. Soybean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CYP2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 was used as an internal control. Data represent mean ± standard error (SE). The experiment was performed twice with similar results.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794025" y="7139700"/>
            <a:ext cx="5410508" cy="17211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2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xpression profile of four </a:t>
            </a:r>
            <a:r>
              <a:rPr lang="en-US" altLang="zh-CN" sz="1200" i="1" kern="1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LBD</a:t>
            </a:r>
            <a:r>
              <a:rPr lang="en-US" altLang="zh-CN" sz="1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s at different soybean tissues.</a:t>
            </a:r>
            <a:endParaRPr lang="zh-CN" altLang="zh-CN" sz="1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otal RNA was extracted from roots, leaves and stems tissues at 3—4-week-old soybean plants. Expression of four </a:t>
            </a:r>
            <a:r>
              <a:rPr lang="en-US" altLang="zh-CN" sz="1200" i="1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LBD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 were determined by </a:t>
            </a:r>
            <a:r>
              <a:rPr lang="en-US" altLang="zh-CN" sz="1200" dirty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qRT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PCR. Soybean 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CYP2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e was used as an internal control. Data represent mean ± standard error (SE). The experiment was performed twice with similar result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2968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69</Words>
  <Application>Microsoft Office PowerPoint</Application>
  <PresentationFormat>A4 纸张(210x297 毫米)</PresentationFormat>
  <Paragraphs>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yl588</dc:creator>
  <cp:lastModifiedBy>qyl588</cp:lastModifiedBy>
  <cp:revision>1</cp:revision>
  <dcterms:created xsi:type="dcterms:W3CDTF">2022-04-04T05:05:39Z</dcterms:created>
  <dcterms:modified xsi:type="dcterms:W3CDTF">2022-04-04T05:10:25Z</dcterms:modified>
</cp:coreProperties>
</file>